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>
        <p:scale>
          <a:sx n="91" d="100"/>
          <a:sy n="91" d="100"/>
        </p:scale>
        <p:origin x="1248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labamax\Desktop\Cin&#233;tique%20CIP%20104459%20+%20LCV4%200803201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Classeur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705124566537155"/>
          <c:y val="5.9043934219980367E-2"/>
          <c:w val="0.80949513703479914"/>
          <c:h val="0.821237331273517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SparkControl magellan Sheet 1'!$DT$6</c:f>
              <c:strCache>
                <c:ptCount val="1"/>
                <c:pt idx="0">
                  <c:v>Control V4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SparkControl magellan Sheet 1'!$DO$7:$DO$55</c:f>
              <c:numCache>
                <c:formatCode>0.0</c:formatCode>
                <c:ptCount val="49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5</c:v>
                </c:pt>
                <c:pt idx="6">
                  <c:v>3</c:v>
                </c:pt>
                <c:pt idx="7">
                  <c:v>3.5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5.5</c:v>
                </c:pt>
                <c:pt idx="12">
                  <c:v>6</c:v>
                </c:pt>
                <c:pt idx="13">
                  <c:v>6.5</c:v>
                </c:pt>
                <c:pt idx="14">
                  <c:v>7</c:v>
                </c:pt>
                <c:pt idx="15">
                  <c:v>7.5</c:v>
                </c:pt>
                <c:pt idx="16">
                  <c:v>8</c:v>
                </c:pt>
                <c:pt idx="17">
                  <c:v>8.5</c:v>
                </c:pt>
                <c:pt idx="18">
                  <c:v>9</c:v>
                </c:pt>
                <c:pt idx="19">
                  <c:v>9.5</c:v>
                </c:pt>
                <c:pt idx="20">
                  <c:v>10</c:v>
                </c:pt>
                <c:pt idx="21">
                  <c:v>10.5</c:v>
                </c:pt>
                <c:pt idx="22">
                  <c:v>11</c:v>
                </c:pt>
                <c:pt idx="23">
                  <c:v>11.5</c:v>
                </c:pt>
                <c:pt idx="24">
                  <c:v>12</c:v>
                </c:pt>
                <c:pt idx="25">
                  <c:v>12.5</c:v>
                </c:pt>
                <c:pt idx="26">
                  <c:v>13</c:v>
                </c:pt>
                <c:pt idx="27">
                  <c:v>13.5</c:v>
                </c:pt>
                <c:pt idx="28">
                  <c:v>14</c:v>
                </c:pt>
                <c:pt idx="29">
                  <c:v>14.5</c:v>
                </c:pt>
                <c:pt idx="30">
                  <c:v>15</c:v>
                </c:pt>
                <c:pt idx="31">
                  <c:v>15.5</c:v>
                </c:pt>
                <c:pt idx="32">
                  <c:v>16</c:v>
                </c:pt>
                <c:pt idx="33">
                  <c:v>16.5</c:v>
                </c:pt>
                <c:pt idx="34">
                  <c:v>17</c:v>
                </c:pt>
                <c:pt idx="35">
                  <c:v>17.5</c:v>
                </c:pt>
                <c:pt idx="36">
                  <c:v>18</c:v>
                </c:pt>
                <c:pt idx="37">
                  <c:v>18.5</c:v>
                </c:pt>
                <c:pt idx="38">
                  <c:v>19</c:v>
                </c:pt>
                <c:pt idx="39">
                  <c:v>19.5</c:v>
                </c:pt>
                <c:pt idx="40">
                  <c:v>20</c:v>
                </c:pt>
                <c:pt idx="41">
                  <c:v>20.5</c:v>
                </c:pt>
                <c:pt idx="42">
                  <c:v>21</c:v>
                </c:pt>
                <c:pt idx="43">
                  <c:v>21.5</c:v>
                </c:pt>
                <c:pt idx="44">
                  <c:v>22</c:v>
                </c:pt>
                <c:pt idx="45">
                  <c:v>22.5</c:v>
                </c:pt>
                <c:pt idx="46">
                  <c:v>23</c:v>
                </c:pt>
                <c:pt idx="47">
                  <c:v>23.5</c:v>
                </c:pt>
                <c:pt idx="48">
                  <c:v>24</c:v>
                </c:pt>
              </c:numCache>
            </c:numRef>
          </c:xVal>
          <c:yVal>
            <c:numRef>
              <c:f>'SparkControl magellan Sheet 1'!$DT$7:$DT$55</c:f>
              <c:numCache>
                <c:formatCode>General</c:formatCode>
                <c:ptCount val="49"/>
                <c:pt idx="0">
                  <c:v>9.0431499999999998E-2</c:v>
                </c:pt>
                <c:pt idx="1">
                  <c:v>0.11371750000000003</c:v>
                </c:pt>
                <c:pt idx="2">
                  <c:v>0.14318749999999997</c:v>
                </c:pt>
                <c:pt idx="3">
                  <c:v>0.19124799999999997</c:v>
                </c:pt>
                <c:pt idx="4">
                  <c:v>0.24387099999999995</c:v>
                </c:pt>
                <c:pt idx="5">
                  <c:v>0.30079000000000006</c:v>
                </c:pt>
                <c:pt idx="6">
                  <c:v>0.36579800000000018</c:v>
                </c:pt>
                <c:pt idx="7">
                  <c:v>0.43603749999999986</c:v>
                </c:pt>
                <c:pt idx="8">
                  <c:v>0.50743550000000004</c:v>
                </c:pt>
                <c:pt idx="9">
                  <c:v>0.58129750000000002</c:v>
                </c:pt>
                <c:pt idx="10">
                  <c:v>0.65166599999999997</c:v>
                </c:pt>
                <c:pt idx="11">
                  <c:v>0.71603250000000007</c:v>
                </c:pt>
                <c:pt idx="12">
                  <c:v>0.7722175</c:v>
                </c:pt>
                <c:pt idx="13">
                  <c:v>0.82158350000000013</c:v>
                </c:pt>
                <c:pt idx="14">
                  <c:v>0.86636050000000009</c:v>
                </c:pt>
                <c:pt idx="15">
                  <c:v>0.89600199999999997</c:v>
                </c:pt>
                <c:pt idx="16">
                  <c:v>0.91200050000000021</c:v>
                </c:pt>
                <c:pt idx="17">
                  <c:v>0.92085950000000016</c:v>
                </c:pt>
                <c:pt idx="18">
                  <c:v>0.92779600000000007</c:v>
                </c:pt>
                <c:pt idx="19">
                  <c:v>0.94283550000000005</c:v>
                </c:pt>
                <c:pt idx="20">
                  <c:v>0.95939849999999993</c:v>
                </c:pt>
                <c:pt idx="21">
                  <c:v>0.98093700000000006</c:v>
                </c:pt>
                <c:pt idx="22">
                  <c:v>1.003379</c:v>
                </c:pt>
                <c:pt idx="23">
                  <c:v>1.0280894999999999</c:v>
                </c:pt>
                <c:pt idx="24">
                  <c:v>1.049995</c:v>
                </c:pt>
                <c:pt idx="25">
                  <c:v>1.0751075000000001</c:v>
                </c:pt>
                <c:pt idx="26">
                  <c:v>1.0975285000000001</c:v>
                </c:pt>
                <c:pt idx="27">
                  <c:v>1.1189200000000001</c:v>
                </c:pt>
                <c:pt idx="28">
                  <c:v>1.1428535</c:v>
                </c:pt>
                <c:pt idx="29">
                  <c:v>1.1659685</c:v>
                </c:pt>
                <c:pt idx="30">
                  <c:v>1.1892900000000002</c:v>
                </c:pt>
                <c:pt idx="31">
                  <c:v>1.2136629999999999</c:v>
                </c:pt>
                <c:pt idx="32">
                  <c:v>1.2322815</c:v>
                </c:pt>
                <c:pt idx="33">
                  <c:v>1.251439</c:v>
                </c:pt>
                <c:pt idx="34">
                  <c:v>1.2681585</c:v>
                </c:pt>
                <c:pt idx="35">
                  <c:v>1.2837689999999999</c:v>
                </c:pt>
                <c:pt idx="36">
                  <c:v>1.3023205000000002</c:v>
                </c:pt>
                <c:pt idx="37">
                  <c:v>1.3164734999999999</c:v>
                </c:pt>
                <c:pt idx="38">
                  <c:v>1.3307579999999999</c:v>
                </c:pt>
                <c:pt idx="39">
                  <c:v>1.341564</c:v>
                </c:pt>
                <c:pt idx="40">
                  <c:v>1.3551825</c:v>
                </c:pt>
                <c:pt idx="41">
                  <c:v>1.3628139999999997</c:v>
                </c:pt>
                <c:pt idx="42">
                  <c:v>1.3687589999999998</c:v>
                </c:pt>
                <c:pt idx="43">
                  <c:v>1.3746040000000002</c:v>
                </c:pt>
                <c:pt idx="44">
                  <c:v>1.3794649999999999</c:v>
                </c:pt>
                <c:pt idx="45">
                  <c:v>1.3856484999999998</c:v>
                </c:pt>
                <c:pt idx="46">
                  <c:v>1.3915145</c:v>
                </c:pt>
                <c:pt idx="47">
                  <c:v>1.3997930000000003</c:v>
                </c:pt>
                <c:pt idx="48">
                  <c:v>1.406562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188-4301-AA77-B459F803C551}"/>
            </c:ext>
          </c:extLst>
        </c:ser>
        <c:ser>
          <c:idx val="1"/>
          <c:order val="1"/>
          <c:tx>
            <c:strRef>
              <c:f>'SparkControl magellan Sheet 1'!$DU$6</c:f>
              <c:strCache>
                <c:ptCount val="1"/>
                <c:pt idx="0">
                  <c:v>V4 + Estradiol 10-6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SparkControl magellan Sheet 1'!$DO$7:$DO$55</c:f>
              <c:numCache>
                <c:formatCode>0.0</c:formatCode>
                <c:ptCount val="49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5</c:v>
                </c:pt>
                <c:pt idx="6">
                  <c:v>3</c:v>
                </c:pt>
                <c:pt idx="7">
                  <c:v>3.5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5.5</c:v>
                </c:pt>
                <c:pt idx="12">
                  <c:v>6</c:v>
                </c:pt>
                <c:pt idx="13">
                  <c:v>6.5</c:v>
                </c:pt>
                <c:pt idx="14">
                  <c:v>7</c:v>
                </c:pt>
                <c:pt idx="15">
                  <c:v>7.5</c:v>
                </c:pt>
                <c:pt idx="16">
                  <c:v>8</c:v>
                </c:pt>
                <c:pt idx="17">
                  <c:v>8.5</c:v>
                </c:pt>
                <c:pt idx="18">
                  <c:v>9</c:v>
                </c:pt>
                <c:pt idx="19">
                  <c:v>9.5</c:v>
                </c:pt>
                <c:pt idx="20">
                  <c:v>10</c:v>
                </c:pt>
                <c:pt idx="21">
                  <c:v>10.5</c:v>
                </c:pt>
                <c:pt idx="22">
                  <c:v>11</c:v>
                </c:pt>
                <c:pt idx="23">
                  <c:v>11.5</c:v>
                </c:pt>
                <c:pt idx="24">
                  <c:v>12</c:v>
                </c:pt>
                <c:pt idx="25">
                  <c:v>12.5</c:v>
                </c:pt>
                <c:pt idx="26">
                  <c:v>13</c:v>
                </c:pt>
                <c:pt idx="27">
                  <c:v>13.5</c:v>
                </c:pt>
                <c:pt idx="28">
                  <c:v>14</c:v>
                </c:pt>
                <c:pt idx="29">
                  <c:v>14.5</c:v>
                </c:pt>
                <c:pt idx="30">
                  <c:v>15</c:v>
                </c:pt>
                <c:pt idx="31">
                  <c:v>15.5</c:v>
                </c:pt>
                <c:pt idx="32">
                  <c:v>16</c:v>
                </c:pt>
                <c:pt idx="33">
                  <c:v>16.5</c:v>
                </c:pt>
                <c:pt idx="34">
                  <c:v>17</c:v>
                </c:pt>
                <c:pt idx="35">
                  <c:v>17.5</c:v>
                </c:pt>
                <c:pt idx="36">
                  <c:v>18</c:v>
                </c:pt>
                <c:pt idx="37">
                  <c:v>18.5</c:v>
                </c:pt>
                <c:pt idx="38">
                  <c:v>19</c:v>
                </c:pt>
                <c:pt idx="39">
                  <c:v>19.5</c:v>
                </c:pt>
                <c:pt idx="40">
                  <c:v>20</c:v>
                </c:pt>
                <c:pt idx="41">
                  <c:v>20.5</c:v>
                </c:pt>
                <c:pt idx="42">
                  <c:v>21</c:v>
                </c:pt>
                <c:pt idx="43">
                  <c:v>21.5</c:v>
                </c:pt>
                <c:pt idx="44">
                  <c:v>22</c:v>
                </c:pt>
                <c:pt idx="45">
                  <c:v>22.5</c:v>
                </c:pt>
                <c:pt idx="46">
                  <c:v>23</c:v>
                </c:pt>
                <c:pt idx="47">
                  <c:v>23.5</c:v>
                </c:pt>
                <c:pt idx="48">
                  <c:v>24</c:v>
                </c:pt>
              </c:numCache>
            </c:numRef>
          </c:xVal>
          <c:yVal>
            <c:numRef>
              <c:f>'SparkControl magellan Sheet 1'!$DU$7:$DU$55</c:f>
              <c:numCache>
                <c:formatCode>General</c:formatCode>
                <c:ptCount val="49"/>
                <c:pt idx="0">
                  <c:v>7.9027499999999917E-2</c:v>
                </c:pt>
                <c:pt idx="1">
                  <c:v>0.1175795</c:v>
                </c:pt>
                <c:pt idx="2">
                  <c:v>0.14064549999999992</c:v>
                </c:pt>
                <c:pt idx="3">
                  <c:v>0.17935400000000001</c:v>
                </c:pt>
                <c:pt idx="4">
                  <c:v>0.22775500000000004</c:v>
                </c:pt>
                <c:pt idx="5">
                  <c:v>0.285584</c:v>
                </c:pt>
                <c:pt idx="6">
                  <c:v>0.34840000000000015</c:v>
                </c:pt>
                <c:pt idx="7">
                  <c:v>0.41529350000000009</c:v>
                </c:pt>
                <c:pt idx="8">
                  <c:v>0.48840149999999993</c:v>
                </c:pt>
                <c:pt idx="9">
                  <c:v>0.56094750000000004</c:v>
                </c:pt>
                <c:pt idx="10">
                  <c:v>0.63170599999999999</c:v>
                </c:pt>
                <c:pt idx="11">
                  <c:v>0.69297249999999999</c:v>
                </c:pt>
                <c:pt idx="12">
                  <c:v>0.74977749999999976</c:v>
                </c:pt>
                <c:pt idx="13">
                  <c:v>0.80132349999999997</c:v>
                </c:pt>
                <c:pt idx="14">
                  <c:v>0.84568049999999984</c:v>
                </c:pt>
                <c:pt idx="15">
                  <c:v>0.88004199999999999</c:v>
                </c:pt>
                <c:pt idx="16">
                  <c:v>0.89972049999999992</c:v>
                </c:pt>
                <c:pt idx="17">
                  <c:v>0.91233950000000008</c:v>
                </c:pt>
                <c:pt idx="18">
                  <c:v>0.92239599999999999</c:v>
                </c:pt>
                <c:pt idx="19">
                  <c:v>0.93237550000000013</c:v>
                </c:pt>
                <c:pt idx="20">
                  <c:v>0.94645849999999998</c:v>
                </c:pt>
                <c:pt idx="21">
                  <c:v>0.96353699999999998</c:v>
                </c:pt>
                <c:pt idx="22">
                  <c:v>0.98237900000000011</c:v>
                </c:pt>
                <c:pt idx="23">
                  <c:v>1.0030895000000002</c:v>
                </c:pt>
                <c:pt idx="24">
                  <c:v>1.0262549999999999</c:v>
                </c:pt>
                <c:pt idx="25">
                  <c:v>1.0467675000000001</c:v>
                </c:pt>
                <c:pt idx="26">
                  <c:v>1.0670485000000003</c:v>
                </c:pt>
                <c:pt idx="27">
                  <c:v>1.09002</c:v>
                </c:pt>
                <c:pt idx="28">
                  <c:v>1.1116735000000002</c:v>
                </c:pt>
                <c:pt idx="29">
                  <c:v>1.1364485000000002</c:v>
                </c:pt>
                <c:pt idx="30">
                  <c:v>1.1617300000000002</c:v>
                </c:pt>
                <c:pt idx="31">
                  <c:v>1.1800829999999998</c:v>
                </c:pt>
                <c:pt idx="32">
                  <c:v>1.2017614999999999</c:v>
                </c:pt>
                <c:pt idx="33">
                  <c:v>1.2183989999999998</c:v>
                </c:pt>
                <c:pt idx="34">
                  <c:v>1.2341185000000001</c:v>
                </c:pt>
                <c:pt idx="35">
                  <c:v>1.2457690000000001</c:v>
                </c:pt>
                <c:pt idx="36">
                  <c:v>1.2562005000000001</c:v>
                </c:pt>
                <c:pt idx="37">
                  <c:v>1.2717935</c:v>
                </c:pt>
                <c:pt idx="38">
                  <c:v>1.2816179999999999</c:v>
                </c:pt>
                <c:pt idx="39">
                  <c:v>1.2917240000000003</c:v>
                </c:pt>
                <c:pt idx="40">
                  <c:v>1.2990425000000001</c:v>
                </c:pt>
                <c:pt idx="41">
                  <c:v>1.3069739999999999</c:v>
                </c:pt>
                <c:pt idx="42">
                  <c:v>1.3141589999999996</c:v>
                </c:pt>
                <c:pt idx="43">
                  <c:v>1.3241239999999999</c:v>
                </c:pt>
                <c:pt idx="44">
                  <c:v>1.3324849999999999</c:v>
                </c:pt>
                <c:pt idx="45">
                  <c:v>1.3414484999999998</c:v>
                </c:pt>
                <c:pt idx="46">
                  <c:v>1.3516144999999997</c:v>
                </c:pt>
                <c:pt idx="47">
                  <c:v>1.361453</c:v>
                </c:pt>
                <c:pt idx="48">
                  <c:v>1.3731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188-4301-AA77-B459F803C551}"/>
            </c:ext>
          </c:extLst>
        </c:ser>
        <c:ser>
          <c:idx val="2"/>
          <c:order val="2"/>
          <c:tx>
            <c:strRef>
              <c:f>'SparkControl magellan Sheet 1'!$DV$6</c:f>
              <c:strCache>
                <c:ptCount val="1"/>
                <c:pt idx="0">
                  <c:v>V4 + Estradiol  10-8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SparkControl magellan Sheet 1'!$DO$7:$DO$55</c:f>
              <c:numCache>
                <c:formatCode>0.0</c:formatCode>
                <c:ptCount val="49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5</c:v>
                </c:pt>
                <c:pt idx="6">
                  <c:v>3</c:v>
                </c:pt>
                <c:pt idx="7">
                  <c:v>3.5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5.5</c:v>
                </c:pt>
                <c:pt idx="12">
                  <c:v>6</c:v>
                </c:pt>
                <c:pt idx="13">
                  <c:v>6.5</c:v>
                </c:pt>
                <c:pt idx="14">
                  <c:v>7</c:v>
                </c:pt>
                <c:pt idx="15">
                  <c:v>7.5</c:v>
                </c:pt>
                <c:pt idx="16">
                  <c:v>8</c:v>
                </c:pt>
                <c:pt idx="17">
                  <c:v>8.5</c:v>
                </c:pt>
                <c:pt idx="18">
                  <c:v>9</c:v>
                </c:pt>
                <c:pt idx="19">
                  <c:v>9.5</c:v>
                </c:pt>
                <c:pt idx="20">
                  <c:v>10</c:v>
                </c:pt>
                <c:pt idx="21">
                  <c:v>10.5</c:v>
                </c:pt>
                <c:pt idx="22">
                  <c:v>11</c:v>
                </c:pt>
                <c:pt idx="23">
                  <c:v>11.5</c:v>
                </c:pt>
                <c:pt idx="24">
                  <c:v>12</c:v>
                </c:pt>
                <c:pt idx="25">
                  <c:v>12.5</c:v>
                </c:pt>
                <c:pt idx="26">
                  <c:v>13</c:v>
                </c:pt>
                <c:pt idx="27">
                  <c:v>13.5</c:v>
                </c:pt>
                <c:pt idx="28">
                  <c:v>14</c:v>
                </c:pt>
                <c:pt idx="29">
                  <c:v>14.5</c:v>
                </c:pt>
                <c:pt idx="30">
                  <c:v>15</c:v>
                </c:pt>
                <c:pt idx="31">
                  <c:v>15.5</c:v>
                </c:pt>
                <c:pt idx="32">
                  <c:v>16</c:v>
                </c:pt>
                <c:pt idx="33">
                  <c:v>16.5</c:v>
                </c:pt>
                <c:pt idx="34">
                  <c:v>17</c:v>
                </c:pt>
                <c:pt idx="35">
                  <c:v>17.5</c:v>
                </c:pt>
                <c:pt idx="36">
                  <c:v>18</c:v>
                </c:pt>
                <c:pt idx="37">
                  <c:v>18.5</c:v>
                </c:pt>
                <c:pt idx="38">
                  <c:v>19</c:v>
                </c:pt>
                <c:pt idx="39">
                  <c:v>19.5</c:v>
                </c:pt>
                <c:pt idx="40">
                  <c:v>20</c:v>
                </c:pt>
                <c:pt idx="41">
                  <c:v>20.5</c:v>
                </c:pt>
                <c:pt idx="42">
                  <c:v>21</c:v>
                </c:pt>
                <c:pt idx="43">
                  <c:v>21.5</c:v>
                </c:pt>
                <c:pt idx="44">
                  <c:v>22</c:v>
                </c:pt>
                <c:pt idx="45">
                  <c:v>22.5</c:v>
                </c:pt>
                <c:pt idx="46">
                  <c:v>23</c:v>
                </c:pt>
                <c:pt idx="47">
                  <c:v>23.5</c:v>
                </c:pt>
                <c:pt idx="48">
                  <c:v>24</c:v>
                </c:pt>
              </c:numCache>
            </c:numRef>
          </c:xVal>
          <c:yVal>
            <c:numRef>
              <c:f>'SparkControl magellan Sheet 1'!$DV$7:$DV$55</c:f>
              <c:numCache>
                <c:formatCode>General</c:formatCode>
                <c:ptCount val="49"/>
                <c:pt idx="0">
                  <c:v>9.1427499999999995E-2</c:v>
                </c:pt>
                <c:pt idx="1">
                  <c:v>0.10404150000000006</c:v>
                </c:pt>
                <c:pt idx="2">
                  <c:v>0.14170149999999998</c:v>
                </c:pt>
                <c:pt idx="3">
                  <c:v>0.18972999999999995</c:v>
                </c:pt>
                <c:pt idx="4">
                  <c:v>0.24239499999999992</c:v>
                </c:pt>
                <c:pt idx="5">
                  <c:v>0.30186600000000002</c:v>
                </c:pt>
                <c:pt idx="6">
                  <c:v>0.36797599999999997</c:v>
                </c:pt>
                <c:pt idx="7">
                  <c:v>0.43663949999999996</c:v>
                </c:pt>
                <c:pt idx="8">
                  <c:v>0.50899549999999993</c:v>
                </c:pt>
                <c:pt idx="9">
                  <c:v>0.5838795</c:v>
                </c:pt>
                <c:pt idx="10">
                  <c:v>0.65400999999999987</c:v>
                </c:pt>
                <c:pt idx="11">
                  <c:v>0.71473249999999999</c:v>
                </c:pt>
                <c:pt idx="12">
                  <c:v>0.77137750000000005</c:v>
                </c:pt>
                <c:pt idx="13">
                  <c:v>0.82194349999999983</c:v>
                </c:pt>
                <c:pt idx="14">
                  <c:v>0.86516049999999978</c:v>
                </c:pt>
                <c:pt idx="15">
                  <c:v>0.8970419999999999</c:v>
                </c:pt>
                <c:pt idx="16">
                  <c:v>0.91304050000000014</c:v>
                </c:pt>
                <c:pt idx="17">
                  <c:v>0.9220394999999999</c:v>
                </c:pt>
                <c:pt idx="18">
                  <c:v>0.9302760000000001</c:v>
                </c:pt>
                <c:pt idx="19">
                  <c:v>0.94153550000000019</c:v>
                </c:pt>
                <c:pt idx="20">
                  <c:v>0.9582385000000001</c:v>
                </c:pt>
                <c:pt idx="21">
                  <c:v>0.97799699999999989</c:v>
                </c:pt>
                <c:pt idx="22">
                  <c:v>0.99915900000000013</c:v>
                </c:pt>
                <c:pt idx="23">
                  <c:v>1.0216095000000001</c:v>
                </c:pt>
                <c:pt idx="24">
                  <c:v>1.0441549999999999</c:v>
                </c:pt>
                <c:pt idx="25">
                  <c:v>1.0661274999999999</c:v>
                </c:pt>
                <c:pt idx="26">
                  <c:v>1.0881284999999998</c:v>
                </c:pt>
                <c:pt idx="27">
                  <c:v>1.1139000000000001</c:v>
                </c:pt>
                <c:pt idx="28">
                  <c:v>1.1373135000000001</c:v>
                </c:pt>
                <c:pt idx="29">
                  <c:v>1.1573884999999999</c:v>
                </c:pt>
                <c:pt idx="30">
                  <c:v>1.1825700000000001</c:v>
                </c:pt>
                <c:pt idx="31">
                  <c:v>1.2019830000000002</c:v>
                </c:pt>
                <c:pt idx="32">
                  <c:v>1.2247815000000002</c:v>
                </c:pt>
                <c:pt idx="33">
                  <c:v>1.2440989999999998</c:v>
                </c:pt>
                <c:pt idx="34">
                  <c:v>1.2657785000000001</c:v>
                </c:pt>
                <c:pt idx="35">
                  <c:v>1.282829</c:v>
                </c:pt>
                <c:pt idx="36">
                  <c:v>1.2968204999999997</c:v>
                </c:pt>
                <c:pt idx="37">
                  <c:v>1.3133735</c:v>
                </c:pt>
                <c:pt idx="38">
                  <c:v>1.3246980000000002</c:v>
                </c:pt>
                <c:pt idx="39">
                  <c:v>1.333564</c:v>
                </c:pt>
                <c:pt idx="40">
                  <c:v>1.3446625000000001</c:v>
                </c:pt>
                <c:pt idx="41">
                  <c:v>1.3511139999999999</c:v>
                </c:pt>
                <c:pt idx="42">
                  <c:v>1.3587389999999999</c:v>
                </c:pt>
                <c:pt idx="43">
                  <c:v>1.367624</c:v>
                </c:pt>
                <c:pt idx="44">
                  <c:v>1.3735850000000001</c:v>
                </c:pt>
                <c:pt idx="45">
                  <c:v>1.3824684999999999</c:v>
                </c:pt>
                <c:pt idx="46">
                  <c:v>1.3901145000000001</c:v>
                </c:pt>
                <c:pt idx="47">
                  <c:v>1.399133</c:v>
                </c:pt>
                <c:pt idx="48">
                  <c:v>1.407623000000000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188-4301-AA77-B459F803C551}"/>
            </c:ext>
          </c:extLst>
        </c:ser>
        <c:ser>
          <c:idx val="3"/>
          <c:order val="3"/>
          <c:tx>
            <c:strRef>
              <c:f>'SparkControl magellan Sheet 1'!$DW$6</c:f>
              <c:strCache>
                <c:ptCount val="1"/>
                <c:pt idx="0">
                  <c:v>V4 + Estradiol 10-10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SparkControl magellan Sheet 1'!$DO$7:$DO$55</c:f>
              <c:numCache>
                <c:formatCode>0.0</c:formatCode>
                <c:ptCount val="49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.5</c:v>
                </c:pt>
                <c:pt idx="4">
                  <c:v>2</c:v>
                </c:pt>
                <c:pt idx="5">
                  <c:v>2.5</c:v>
                </c:pt>
                <c:pt idx="6">
                  <c:v>3</c:v>
                </c:pt>
                <c:pt idx="7">
                  <c:v>3.5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5.5</c:v>
                </c:pt>
                <c:pt idx="12">
                  <c:v>6</c:v>
                </c:pt>
                <c:pt idx="13">
                  <c:v>6.5</c:v>
                </c:pt>
                <c:pt idx="14">
                  <c:v>7</c:v>
                </c:pt>
                <c:pt idx="15">
                  <c:v>7.5</c:v>
                </c:pt>
                <c:pt idx="16">
                  <c:v>8</c:v>
                </c:pt>
                <c:pt idx="17">
                  <c:v>8.5</c:v>
                </c:pt>
                <c:pt idx="18">
                  <c:v>9</c:v>
                </c:pt>
                <c:pt idx="19">
                  <c:v>9.5</c:v>
                </c:pt>
                <c:pt idx="20">
                  <c:v>10</c:v>
                </c:pt>
                <c:pt idx="21">
                  <c:v>10.5</c:v>
                </c:pt>
                <c:pt idx="22">
                  <c:v>11</c:v>
                </c:pt>
                <c:pt idx="23">
                  <c:v>11.5</c:v>
                </c:pt>
                <c:pt idx="24">
                  <c:v>12</c:v>
                </c:pt>
                <c:pt idx="25">
                  <c:v>12.5</c:v>
                </c:pt>
                <c:pt idx="26">
                  <c:v>13</c:v>
                </c:pt>
                <c:pt idx="27">
                  <c:v>13.5</c:v>
                </c:pt>
                <c:pt idx="28">
                  <c:v>14</c:v>
                </c:pt>
                <c:pt idx="29">
                  <c:v>14.5</c:v>
                </c:pt>
                <c:pt idx="30">
                  <c:v>15</c:v>
                </c:pt>
                <c:pt idx="31">
                  <c:v>15.5</c:v>
                </c:pt>
                <c:pt idx="32">
                  <c:v>16</c:v>
                </c:pt>
                <c:pt idx="33">
                  <c:v>16.5</c:v>
                </c:pt>
                <c:pt idx="34">
                  <c:v>17</c:v>
                </c:pt>
                <c:pt idx="35">
                  <c:v>17.5</c:v>
                </c:pt>
                <c:pt idx="36">
                  <c:v>18</c:v>
                </c:pt>
                <c:pt idx="37">
                  <c:v>18.5</c:v>
                </c:pt>
                <c:pt idx="38">
                  <c:v>19</c:v>
                </c:pt>
                <c:pt idx="39">
                  <c:v>19.5</c:v>
                </c:pt>
                <c:pt idx="40">
                  <c:v>20</c:v>
                </c:pt>
                <c:pt idx="41">
                  <c:v>20.5</c:v>
                </c:pt>
                <c:pt idx="42">
                  <c:v>21</c:v>
                </c:pt>
                <c:pt idx="43">
                  <c:v>21.5</c:v>
                </c:pt>
                <c:pt idx="44">
                  <c:v>22</c:v>
                </c:pt>
                <c:pt idx="45">
                  <c:v>22.5</c:v>
                </c:pt>
                <c:pt idx="46">
                  <c:v>23</c:v>
                </c:pt>
                <c:pt idx="47">
                  <c:v>23.5</c:v>
                </c:pt>
                <c:pt idx="48">
                  <c:v>24</c:v>
                </c:pt>
              </c:numCache>
            </c:numRef>
          </c:xVal>
          <c:yVal>
            <c:numRef>
              <c:f>'SparkControl magellan Sheet 1'!$DW$7:$DW$55</c:f>
              <c:numCache>
                <c:formatCode>General</c:formatCode>
                <c:ptCount val="49"/>
                <c:pt idx="0">
                  <c:v>7.8613500000000003E-2</c:v>
                </c:pt>
                <c:pt idx="1">
                  <c:v>0.10266750000000002</c:v>
                </c:pt>
                <c:pt idx="2">
                  <c:v>0.13715150000000004</c:v>
                </c:pt>
                <c:pt idx="3">
                  <c:v>0.17849799999999993</c:v>
                </c:pt>
                <c:pt idx="4">
                  <c:v>0.2254870000000001</c:v>
                </c:pt>
                <c:pt idx="5">
                  <c:v>0.28049000000000007</c:v>
                </c:pt>
                <c:pt idx="6">
                  <c:v>0.34317000000000009</c:v>
                </c:pt>
                <c:pt idx="7">
                  <c:v>0.41147749999999994</c:v>
                </c:pt>
                <c:pt idx="8">
                  <c:v>0.48535549999999994</c:v>
                </c:pt>
                <c:pt idx="9">
                  <c:v>0.55830950000000001</c:v>
                </c:pt>
                <c:pt idx="10">
                  <c:v>0.62832399999999988</c:v>
                </c:pt>
                <c:pt idx="11">
                  <c:v>0.69107249999999998</c:v>
                </c:pt>
                <c:pt idx="12">
                  <c:v>0.74669750000000001</c:v>
                </c:pt>
                <c:pt idx="13">
                  <c:v>0.79682350000000002</c:v>
                </c:pt>
                <c:pt idx="14">
                  <c:v>0.84168050000000005</c:v>
                </c:pt>
                <c:pt idx="15">
                  <c:v>0.87494199999999989</c:v>
                </c:pt>
                <c:pt idx="16">
                  <c:v>0.89442050000000028</c:v>
                </c:pt>
                <c:pt idx="17">
                  <c:v>0.90657950000000009</c:v>
                </c:pt>
                <c:pt idx="18">
                  <c:v>0.91577599999999992</c:v>
                </c:pt>
                <c:pt idx="19">
                  <c:v>0.92575550000000006</c:v>
                </c:pt>
                <c:pt idx="20">
                  <c:v>0.94063850000000004</c:v>
                </c:pt>
                <c:pt idx="21">
                  <c:v>0.95913700000000002</c:v>
                </c:pt>
                <c:pt idx="22">
                  <c:v>0.97883899999999979</c:v>
                </c:pt>
                <c:pt idx="23">
                  <c:v>1.0014895000000001</c:v>
                </c:pt>
                <c:pt idx="24">
                  <c:v>1.023075</c:v>
                </c:pt>
                <c:pt idx="25">
                  <c:v>1.0443875</c:v>
                </c:pt>
                <c:pt idx="26">
                  <c:v>1.0637084999999997</c:v>
                </c:pt>
                <c:pt idx="27">
                  <c:v>1.0869599999999999</c:v>
                </c:pt>
                <c:pt idx="28">
                  <c:v>1.1105935</c:v>
                </c:pt>
                <c:pt idx="29">
                  <c:v>1.1350284999999998</c:v>
                </c:pt>
                <c:pt idx="30">
                  <c:v>1.1616300000000002</c:v>
                </c:pt>
                <c:pt idx="31">
                  <c:v>1.1892429999999998</c:v>
                </c:pt>
                <c:pt idx="32">
                  <c:v>1.2164414999999997</c:v>
                </c:pt>
                <c:pt idx="33">
                  <c:v>1.2403590000000002</c:v>
                </c:pt>
                <c:pt idx="34">
                  <c:v>1.2636585</c:v>
                </c:pt>
                <c:pt idx="35">
                  <c:v>1.2795489999999998</c:v>
                </c:pt>
                <c:pt idx="36">
                  <c:v>1.2924804999999999</c:v>
                </c:pt>
                <c:pt idx="37">
                  <c:v>1.3017535</c:v>
                </c:pt>
                <c:pt idx="38">
                  <c:v>1.3121579999999999</c:v>
                </c:pt>
                <c:pt idx="39">
                  <c:v>1.320764</c:v>
                </c:pt>
                <c:pt idx="40">
                  <c:v>1.3295024999999998</c:v>
                </c:pt>
                <c:pt idx="41">
                  <c:v>1.3357740000000002</c:v>
                </c:pt>
                <c:pt idx="42">
                  <c:v>1.3425590000000005</c:v>
                </c:pt>
                <c:pt idx="43">
                  <c:v>1.349504</c:v>
                </c:pt>
                <c:pt idx="44">
                  <c:v>1.3536649999999999</c:v>
                </c:pt>
                <c:pt idx="45">
                  <c:v>1.3631284999999997</c:v>
                </c:pt>
                <c:pt idx="46">
                  <c:v>1.3726744999999996</c:v>
                </c:pt>
                <c:pt idx="47">
                  <c:v>1.382673</c:v>
                </c:pt>
                <c:pt idx="48">
                  <c:v>1.393083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188-4301-AA77-B459F803C5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60607616"/>
        <c:axId val="960605984"/>
      </c:scatterChart>
      <c:valAx>
        <c:axId val="960607616"/>
        <c:scaling>
          <c:orientation val="minMax"/>
          <c:max val="24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Time (h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60605984"/>
        <c:crosses val="autoZero"/>
        <c:crossBetween val="midCat"/>
      </c:valAx>
      <c:valAx>
        <c:axId val="960605984"/>
        <c:scaling>
          <c:logBase val="10"/>
          <c:orientation val="minMax"/>
          <c:max val="1.5"/>
          <c:min val="0.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OD600nm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606076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Feuil1!$B$7</c:f>
              <c:strCache>
                <c:ptCount val="1"/>
                <c:pt idx="0">
                  <c:v>Control 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Feuil1!$A$8:$A$43</c:f>
              <c:numCache>
                <c:formatCode>General</c:formatCode>
                <c:ptCount val="36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  <c:pt idx="22">
                  <c:v>46</c:v>
                </c:pt>
                <c:pt idx="23">
                  <c:v>48</c:v>
                </c:pt>
                <c:pt idx="24">
                  <c:v>50</c:v>
                </c:pt>
                <c:pt idx="25">
                  <c:v>52</c:v>
                </c:pt>
                <c:pt idx="26">
                  <c:v>54</c:v>
                </c:pt>
                <c:pt idx="27">
                  <c:v>56</c:v>
                </c:pt>
                <c:pt idx="28">
                  <c:v>58</c:v>
                </c:pt>
                <c:pt idx="29">
                  <c:v>60</c:v>
                </c:pt>
                <c:pt idx="30">
                  <c:v>62</c:v>
                </c:pt>
                <c:pt idx="31">
                  <c:v>64</c:v>
                </c:pt>
                <c:pt idx="32">
                  <c:v>66</c:v>
                </c:pt>
                <c:pt idx="33">
                  <c:v>68</c:v>
                </c:pt>
                <c:pt idx="34">
                  <c:v>70</c:v>
                </c:pt>
                <c:pt idx="35">
                  <c:v>72</c:v>
                </c:pt>
              </c:numCache>
            </c:numRef>
          </c:xVal>
          <c:yVal>
            <c:numRef>
              <c:f>Feuil1!$B$8:$B$43</c:f>
              <c:numCache>
                <c:formatCode>General</c:formatCode>
                <c:ptCount val="36"/>
                <c:pt idx="0">
                  <c:v>0.35375000000000001</c:v>
                </c:pt>
                <c:pt idx="1">
                  <c:v>0.34571999999999997</c:v>
                </c:pt>
                <c:pt idx="2">
                  <c:v>0.67954999999999999</c:v>
                </c:pt>
                <c:pt idx="3">
                  <c:v>1.0657924999999999</c:v>
                </c:pt>
                <c:pt idx="4">
                  <c:v>1.1619000000000002</c:v>
                </c:pt>
                <c:pt idx="5">
                  <c:v>1.197025</c:v>
                </c:pt>
                <c:pt idx="6">
                  <c:v>1.213425</c:v>
                </c:pt>
                <c:pt idx="7">
                  <c:v>1.22655</c:v>
                </c:pt>
                <c:pt idx="8">
                  <c:v>1.2381500000000001</c:v>
                </c:pt>
                <c:pt idx="9">
                  <c:v>1.2481</c:v>
                </c:pt>
                <c:pt idx="10">
                  <c:v>1.2573999999999999</c:v>
                </c:pt>
                <c:pt idx="11">
                  <c:v>1.2651250000000001</c:v>
                </c:pt>
                <c:pt idx="12">
                  <c:v>1.2739</c:v>
                </c:pt>
                <c:pt idx="13">
                  <c:v>1.2813749999999999</c:v>
                </c:pt>
                <c:pt idx="14">
                  <c:v>1.2873250000000001</c:v>
                </c:pt>
                <c:pt idx="15">
                  <c:v>1.295825</c:v>
                </c:pt>
                <c:pt idx="16">
                  <c:v>1.302025</c:v>
                </c:pt>
                <c:pt idx="17">
                  <c:v>1.3087</c:v>
                </c:pt>
                <c:pt idx="18">
                  <c:v>1.314775</c:v>
                </c:pt>
                <c:pt idx="19">
                  <c:v>1.31985</c:v>
                </c:pt>
                <c:pt idx="20">
                  <c:v>1.3247</c:v>
                </c:pt>
                <c:pt idx="21">
                  <c:v>1.329175</c:v>
                </c:pt>
                <c:pt idx="22">
                  <c:v>1.3336749999999999</c:v>
                </c:pt>
                <c:pt idx="23">
                  <c:v>1.338875</c:v>
                </c:pt>
                <c:pt idx="24">
                  <c:v>1.3416250000000001</c:v>
                </c:pt>
                <c:pt idx="25">
                  <c:v>1.3462999999999998</c:v>
                </c:pt>
                <c:pt idx="26">
                  <c:v>1.350425</c:v>
                </c:pt>
                <c:pt idx="27">
                  <c:v>1.3546</c:v>
                </c:pt>
                <c:pt idx="28">
                  <c:v>1.3583000000000001</c:v>
                </c:pt>
                <c:pt idx="29">
                  <c:v>1.3600749999999999</c:v>
                </c:pt>
                <c:pt idx="30">
                  <c:v>1.3652500000000001</c:v>
                </c:pt>
                <c:pt idx="31">
                  <c:v>1.3670250000000002</c:v>
                </c:pt>
                <c:pt idx="32">
                  <c:v>1.3696250000000001</c:v>
                </c:pt>
                <c:pt idx="33">
                  <c:v>1.3721999999999999</c:v>
                </c:pt>
                <c:pt idx="34">
                  <c:v>1.3755999999999999</c:v>
                </c:pt>
                <c:pt idx="35">
                  <c:v>1.3784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33E3-46C6-B4AD-4B4790C0E22A}"/>
            </c:ext>
          </c:extLst>
        </c:ser>
        <c:ser>
          <c:idx val="1"/>
          <c:order val="1"/>
          <c:tx>
            <c:strRef>
              <c:f>Feuil1!$D$7</c:f>
              <c:strCache>
                <c:ptCount val="1"/>
                <c:pt idx="0">
                  <c:v>E 10-6 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Feuil1!$A$8:$A$43</c:f>
              <c:numCache>
                <c:formatCode>General</c:formatCode>
                <c:ptCount val="36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  <c:pt idx="22">
                  <c:v>46</c:v>
                </c:pt>
                <c:pt idx="23">
                  <c:v>48</c:v>
                </c:pt>
                <c:pt idx="24">
                  <c:v>50</c:v>
                </c:pt>
                <c:pt idx="25">
                  <c:v>52</c:v>
                </c:pt>
                <c:pt idx="26">
                  <c:v>54</c:v>
                </c:pt>
                <c:pt idx="27">
                  <c:v>56</c:v>
                </c:pt>
                <c:pt idx="28">
                  <c:v>58</c:v>
                </c:pt>
                <c:pt idx="29">
                  <c:v>60</c:v>
                </c:pt>
                <c:pt idx="30">
                  <c:v>62</c:v>
                </c:pt>
                <c:pt idx="31">
                  <c:v>64</c:v>
                </c:pt>
                <c:pt idx="32">
                  <c:v>66</c:v>
                </c:pt>
                <c:pt idx="33">
                  <c:v>68</c:v>
                </c:pt>
                <c:pt idx="34">
                  <c:v>70</c:v>
                </c:pt>
                <c:pt idx="35">
                  <c:v>72</c:v>
                </c:pt>
              </c:numCache>
            </c:numRef>
          </c:xVal>
          <c:yVal>
            <c:numRef>
              <c:f>Feuil1!$D$8:$D$43</c:f>
              <c:numCache>
                <c:formatCode>General</c:formatCode>
                <c:ptCount val="36"/>
                <c:pt idx="0">
                  <c:v>0.37258249999999998</c:v>
                </c:pt>
                <c:pt idx="1">
                  <c:v>0.34300999999999998</c:v>
                </c:pt>
                <c:pt idx="2">
                  <c:v>0.6963975</c:v>
                </c:pt>
                <c:pt idx="3">
                  <c:v>1.1091525</c:v>
                </c:pt>
                <c:pt idx="4">
                  <c:v>1.1978</c:v>
                </c:pt>
                <c:pt idx="5">
                  <c:v>1.225425</c:v>
                </c:pt>
                <c:pt idx="6">
                  <c:v>1.2382499999999999</c:v>
                </c:pt>
                <c:pt idx="7">
                  <c:v>1.2503249999999999</c:v>
                </c:pt>
                <c:pt idx="8">
                  <c:v>1.2600750000000001</c:v>
                </c:pt>
                <c:pt idx="9">
                  <c:v>1.2701250000000002</c:v>
                </c:pt>
                <c:pt idx="10">
                  <c:v>1.2770999999999999</c:v>
                </c:pt>
                <c:pt idx="11">
                  <c:v>1.286125</c:v>
                </c:pt>
                <c:pt idx="12">
                  <c:v>1.2934999999999999</c:v>
                </c:pt>
                <c:pt idx="13">
                  <c:v>1.300775</c:v>
                </c:pt>
                <c:pt idx="14">
                  <c:v>1.307075</c:v>
                </c:pt>
                <c:pt idx="15">
                  <c:v>1.3137249999999998</c:v>
                </c:pt>
                <c:pt idx="16">
                  <c:v>1.31935</c:v>
                </c:pt>
                <c:pt idx="17">
                  <c:v>1.3265250000000002</c:v>
                </c:pt>
                <c:pt idx="18">
                  <c:v>1.3323</c:v>
                </c:pt>
                <c:pt idx="19">
                  <c:v>1.3356749999999999</c:v>
                </c:pt>
                <c:pt idx="20">
                  <c:v>1.3418750000000002</c:v>
                </c:pt>
                <c:pt idx="21">
                  <c:v>1.3463750000000001</c:v>
                </c:pt>
                <c:pt idx="22">
                  <c:v>1.3509249999999999</c:v>
                </c:pt>
                <c:pt idx="23">
                  <c:v>1.355175</c:v>
                </c:pt>
                <c:pt idx="24">
                  <c:v>1.35785</c:v>
                </c:pt>
                <c:pt idx="25">
                  <c:v>1.3626750000000001</c:v>
                </c:pt>
                <c:pt idx="26">
                  <c:v>1.3659749999999999</c:v>
                </c:pt>
                <c:pt idx="27">
                  <c:v>1.36965</c:v>
                </c:pt>
                <c:pt idx="28">
                  <c:v>1.3740000000000001</c:v>
                </c:pt>
                <c:pt idx="29">
                  <c:v>1.3758249999999999</c:v>
                </c:pt>
                <c:pt idx="30">
                  <c:v>1.3812249999999999</c:v>
                </c:pt>
                <c:pt idx="31">
                  <c:v>1.3823750000000001</c:v>
                </c:pt>
                <c:pt idx="32">
                  <c:v>1.3845499999999999</c:v>
                </c:pt>
                <c:pt idx="33">
                  <c:v>1.3856000000000002</c:v>
                </c:pt>
                <c:pt idx="34">
                  <c:v>1.3913500000000001</c:v>
                </c:pt>
                <c:pt idx="35">
                  <c:v>1.392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33E3-46C6-B4AD-4B4790C0E22A}"/>
            </c:ext>
          </c:extLst>
        </c:ser>
        <c:ser>
          <c:idx val="2"/>
          <c:order val="2"/>
          <c:tx>
            <c:strRef>
              <c:f>Feuil1!$F$7</c:f>
              <c:strCache>
                <c:ptCount val="1"/>
                <c:pt idx="0">
                  <c:v>E 10-8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Feuil1!$A$8:$A$43</c:f>
              <c:numCache>
                <c:formatCode>General</c:formatCode>
                <c:ptCount val="36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  <c:pt idx="22">
                  <c:v>46</c:v>
                </c:pt>
                <c:pt idx="23">
                  <c:v>48</c:v>
                </c:pt>
                <c:pt idx="24">
                  <c:v>50</c:v>
                </c:pt>
                <c:pt idx="25">
                  <c:v>52</c:v>
                </c:pt>
                <c:pt idx="26">
                  <c:v>54</c:v>
                </c:pt>
                <c:pt idx="27">
                  <c:v>56</c:v>
                </c:pt>
                <c:pt idx="28">
                  <c:v>58</c:v>
                </c:pt>
                <c:pt idx="29">
                  <c:v>60</c:v>
                </c:pt>
                <c:pt idx="30">
                  <c:v>62</c:v>
                </c:pt>
                <c:pt idx="31">
                  <c:v>64</c:v>
                </c:pt>
                <c:pt idx="32">
                  <c:v>66</c:v>
                </c:pt>
                <c:pt idx="33">
                  <c:v>68</c:v>
                </c:pt>
                <c:pt idx="34">
                  <c:v>70</c:v>
                </c:pt>
                <c:pt idx="35">
                  <c:v>72</c:v>
                </c:pt>
              </c:numCache>
            </c:numRef>
          </c:xVal>
          <c:yVal>
            <c:numRef>
              <c:f>Feuil1!$F$8:$F$43</c:f>
              <c:numCache>
                <c:formatCode>General</c:formatCode>
                <c:ptCount val="36"/>
                <c:pt idx="0">
                  <c:v>0.370805</c:v>
                </c:pt>
                <c:pt idx="1">
                  <c:v>0.37859749999999998</c:v>
                </c:pt>
                <c:pt idx="2">
                  <c:v>0.76834500000000006</c:v>
                </c:pt>
                <c:pt idx="3">
                  <c:v>1.1651499999999999</c:v>
                </c:pt>
                <c:pt idx="4">
                  <c:v>1.2369999999999999</c:v>
                </c:pt>
                <c:pt idx="5">
                  <c:v>1.25895</c:v>
                </c:pt>
                <c:pt idx="6">
                  <c:v>1.2706</c:v>
                </c:pt>
                <c:pt idx="7">
                  <c:v>1.27915</c:v>
                </c:pt>
                <c:pt idx="8">
                  <c:v>1.28925</c:v>
                </c:pt>
                <c:pt idx="9">
                  <c:v>1.2963750000000001</c:v>
                </c:pt>
                <c:pt idx="10">
                  <c:v>1.3022</c:v>
                </c:pt>
                <c:pt idx="11">
                  <c:v>1.308775</c:v>
                </c:pt>
                <c:pt idx="12">
                  <c:v>1.3149500000000001</c:v>
                </c:pt>
                <c:pt idx="13">
                  <c:v>1.3226</c:v>
                </c:pt>
                <c:pt idx="14">
                  <c:v>1.3283749999999999</c:v>
                </c:pt>
                <c:pt idx="15">
                  <c:v>1.3328</c:v>
                </c:pt>
                <c:pt idx="16">
                  <c:v>1.338025</c:v>
                </c:pt>
                <c:pt idx="17">
                  <c:v>1.3441750000000001</c:v>
                </c:pt>
                <c:pt idx="18">
                  <c:v>1.3494249999999999</c:v>
                </c:pt>
                <c:pt idx="19">
                  <c:v>1.3520249999999998</c:v>
                </c:pt>
                <c:pt idx="20">
                  <c:v>1.3562749999999999</c:v>
                </c:pt>
                <c:pt idx="21">
                  <c:v>1.3603749999999999</c:v>
                </c:pt>
                <c:pt idx="22">
                  <c:v>1.3645750000000001</c:v>
                </c:pt>
                <c:pt idx="23">
                  <c:v>1.3677250000000001</c:v>
                </c:pt>
                <c:pt idx="24">
                  <c:v>1.3715499999999998</c:v>
                </c:pt>
                <c:pt idx="25">
                  <c:v>1.3745000000000001</c:v>
                </c:pt>
                <c:pt idx="26">
                  <c:v>1.3775249999999999</c:v>
                </c:pt>
                <c:pt idx="27">
                  <c:v>1.3812500000000001</c:v>
                </c:pt>
                <c:pt idx="28">
                  <c:v>1.38435</c:v>
                </c:pt>
                <c:pt idx="29">
                  <c:v>1.3865499999999999</c:v>
                </c:pt>
                <c:pt idx="30">
                  <c:v>1.3892250000000002</c:v>
                </c:pt>
                <c:pt idx="31">
                  <c:v>1.3925749999999999</c:v>
                </c:pt>
                <c:pt idx="32">
                  <c:v>1.3929499999999999</c:v>
                </c:pt>
                <c:pt idx="33">
                  <c:v>1.3958249999999999</c:v>
                </c:pt>
                <c:pt idx="34">
                  <c:v>1.39835</c:v>
                </c:pt>
                <c:pt idx="35">
                  <c:v>1.4002249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33E3-46C6-B4AD-4B4790C0E22A}"/>
            </c:ext>
          </c:extLst>
        </c:ser>
        <c:ser>
          <c:idx val="3"/>
          <c:order val="3"/>
          <c:tx>
            <c:strRef>
              <c:f>Feuil1!$H$7</c:f>
              <c:strCache>
                <c:ptCount val="1"/>
                <c:pt idx="0">
                  <c:v>E 10-10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Feuil1!$A$8:$A$43</c:f>
              <c:numCache>
                <c:formatCode>General</c:formatCode>
                <c:ptCount val="36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2</c:v>
                </c:pt>
                <c:pt idx="6">
                  <c:v>14</c:v>
                </c:pt>
                <c:pt idx="7">
                  <c:v>16</c:v>
                </c:pt>
                <c:pt idx="8">
                  <c:v>18</c:v>
                </c:pt>
                <c:pt idx="9">
                  <c:v>20</c:v>
                </c:pt>
                <c:pt idx="10">
                  <c:v>22</c:v>
                </c:pt>
                <c:pt idx="11">
                  <c:v>24</c:v>
                </c:pt>
                <c:pt idx="12">
                  <c:v>26</c:v>
                </c:pt>
                <c:pt idx="13">
                  <c:v>28</c:v>
                </c:pt>
                <c:pt idx="14">
                  <c:v>30</c:v>
                </c:pt>
                <c:pt idx="15">
                  <c:v>32</c:v>
                </c:pt>
                <c:pt idx="16">
                  <c:v>34</c:v>
                </c:pt>
                <c:pt idx="17">
                  <c:v>36</c:v>
                </c:pt>
                <c:pt idx="18">
                  <c:v>38</c:v>
                </c:pt>
                <c:pt idx="19">
                  <c:v>40</c:v>
                </c:pt>
                <c:pt idx="20">
                  <c:v>42</c:v>
                </c:pt>
                <c:pt idx="21">
                  <c:v>44</c:v>
                </c:pt>
                <c:pt idx="22">
                  <c:v>46</c:v>
                </c:pt>
                <c:pt idx="23">
                  <c:v>48</c:v>
                </c:pt>
                <c:pt idx="24">
                  <c:v>50</c:v>
                </c:pt>
                <c:pt idx="25">
                  <c:v>52</c:v>
                </c:pt>
                <c:pt idx="26">
                  <c:v>54</c:v>
                </c:pt>
                <c:pt idx="27">
                  <c:v>56</c:v>
                </c:pt>
                <c:pt idx="28">
                  <c:v>58</c:v>
                </c:pt>
                <c:pt idx="29">
                  <c:v>60</c:v>
                </c:pt>
                <c:pt idx="30">
                  <c:v>62</c:v>
                </c:pt>
                <c:pt idx="31">
                  <c:v>64</c:v>
                </c:pt>
                <c:pt idx="32">
                  <c:v>66</c:v>
                </c:pt>
                <c:pt idx="33">
                  <c:v>68</c:v>
                </c:pt>
                <c:pt idx="34">
                  <c:v>70</c:v>
                </c:pt>
                <c:pt idx="35">
                  <c:v>72</c:v>
                </c:pt>
              </c:numCache>
            </c:numRef>
          </c:xVal>
          <c:yVal>
            <c:numRef>
              <c:f>Feuil1!$H$8:$H$43</c:f>
              <c:numCache>
                <c:formatCode>General</c:formatCode>
                <c:ptCount val="36"/>
                <c:pt idx="0">
                  <c:v>0.38598749999999998</c:v>
                </c:pt>
                <c:pt idx="1">
                  <c:v>0.3356925</c:v>
                </c:pt>
                <c:pt idx="2">
                  <c:v>0.54834499999999997</c:v>
                </c:pt>
                <c:pt idx="3">
                  <c:v>1.1082799999999999</c:v>
                </c:pt>
                <c:pt idx="4">
                  <c:v>1.2216500000000001</c:v>
                </c:pt>
                <c:pt idx="5">
                  <c:v>1.256775</c:v>
                </c:pt>
                <c:pt idx="6">
                  <c:v>1.27295</c:v>
                </c:pt>
                <c:pt idx="7">
                  <c:v>1.285525</c:v>
                </c:pt>
                <c:pt idx="8">
                  <c:v>1.295925</c:v>
                </c:pt>
                <c:pt idx="9">
                  <c:v>1.3054749999999999</c:v>
                </c:pt>
                <c:pt idx="10">
                  <c:v>1.31385</c:v>
                </c:pt>
                <c:pt idx="11">
                  <c:v>1.320875</c:v>
                </c:pt>
                <c:pt idx="12">
                  <c:v>1.3269000000000002</c:v>
                </c:pt>
                <c:pt idx="13">
                  <c:v>1.3324750000000001</c:v>
                </c:pt>
                <c:pt idx="14">
                  <c:v>1.34145</c:v>
                </c:pt>
                <c:pt idx="15">
                  <c:v>1.3475249999999999</c:v>
                </c:pt>
                <c:pt idx="16">
                  <c:v>1.3539999999999999</c:v>
                </c:pt>
                <c:pt idx="17">
                  <c:v>1.3588499999999999</c:v>
                </c:pt>
                <c:pt idx="18">
                  <c:v>1.3647999999999998</c:v>
                </c:pt>
                <c:pt idx="19">
                  <c:v>1.3684499999999997</c:v>
                </c:pt>
                <c:pt idx="20">
                  <c:v>1.37185</c:v>
                </c:pt>
                <c:pt idx="21">
                  <c:v>1.37635</c:v>
                </c:pt>
                <c:pt idx="22">
                  <c:v>1.3794999999999999</c:v>
                </c:pt>
                <c:pt idx="23">
                  <c:v>1.384525</c:v>
                </c:pt>
                <c:pt idx="24">
                  <c:v>1.388825</c:v>
                </c:pt>
                <c:pt idx="25">
                  <c:v>1.3894250000000001</c:v>
                </c:pt>
                <c:pt idx="26">
                  <c:v>1.394625</c:v>
                </c:pt>
                <c:pt idx="27">
                  <c:v>1.3982000000000001</c:v>
                </c:pt>
                <c:pt idx="28">
                  <c:v>1.4008500000000002</c:v>
                </c:pt>
                <c:pt idx="29">
                  <c:v>1.4033499999999999</c:v>
                </c:pt>
                <c:pt idx="30">
                  <c:v>1.4046749999999999</c:v>
                </c:pt>
                <c:pt idx="31">
                  <c:v>1.4078999999999999</c:v>
                </c:pt>
                <c:pt idx="32">
                  <c:v>1.409675</c:v>
                </c:pt>
                <c:pt idx="33">
                  <c:v>1.4119499999999998</c:v>
                </c:pt>
                <c:pt idx="34">
                  <c:v>1.4129999999999998</c:v>
                </c:pt>
                <c:pt idx="35">
                  <c:v>1.4161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33E3-46C6-B4AD-4B4790C0E2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0752575"/>
        <c:axId val="70750911"/>
      </c:scatterChart>
      <c:valAx>
        <c:axId val="70752575"/>
        <c:scaling>
          <c:orientation val="minMax"/>
          <c:max val="72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0750911"/>
        <c:crosses val="autoZero"/>
        <c:crossBetween val="midCat"/>
      </c:valAx>
      <c:valAx>
        <c:axId val="70750911"/>
        <c:scaling>
          <c:logBase val="10"/>
          <c:orientation val="minMax"/>
          <c:max val="1.9"/>
          <c:min val="0.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075257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899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4490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8876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5446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3508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330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4716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3743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1943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0289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5842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B3ABF-9FAC-4A61-A693-CACD08FFA400}" type="datetimeFigureOut">
              <a:rPr lang="fr-FR" smtClean="0"/>
              <a:t>11/05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E9FE3-E693-49A6-838C-626A7127FC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4840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0827996"/>
              </p:ext>
            </p:extLst>
          </p:nvPr>
        </p:nvGraphicFramePr>
        <p:xfrm>
          <a:off x="254701" y="1056290"/>
          <a:ext cx="6130860" cy="37542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Ellipse 3"/>
          <p:cNvSpPr/>
          <p:nvPr/>
        </p:nvSpPr>
        <p:spPr>
          <a:xfrm>
            <a:off x="4323028" y="3081374"/>
            <a:ext cx="72427" cy="78185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Ellipse 4"/>
          <p:cNvSpPr/>
          <p:nvPr/>
        </p:nvSpPr>
        <p:spPr>
          <a:xfrm>
            <a:off x="4323029" y="3264146"/>
            <a:ext cx="72427" cy="78185"/>
          </a:xfrm>
          <a:prstGeom prst="ellipse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Ellipse 5"/>
          <p:cNvSpPr/>
          <p:nvPr/>
        </p:nvSpPr>
        <p:spPr>
          <a:xfrm>
            <a:off x="4323029" y="3452169"/>
            <a:ext cx="72427" cy="78185"/>
          </a:xfrm>
          <a:prstGeom prst="ellipse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Ellipse 6"/>
          <p:cNvSpPr/>
          <p:nvPr/>
        </p:nvSpPr>
        <p:spPr>
          <a:xfrm>
            <a:off x="4323030" y="3640192"/>
            <a:ext cx="72427" cy="78185"/>
          </a:xfrm>
          <a:prstGeom prst="ellipse">
            <a:avLst/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ZoneTexte 7"/>
          <p:cNvSpPr txBox="1"/>
          <p:nvPr/>
        </p:nvSpPr>
        <p:spPr>
          <a:xfrm>
            <a:off x="4395455" y="2999968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Control </a:t>
            </a:r>
            <a:endParaRPr lang="fr-FR" sz="1000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4395455" y="3178842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17</a:t>
            </a:r>
            <a:r>
              <a:rPr lang="el-GR" sz="1000" b="1" dirty="0" smtClean="0"/>
              <a:t>β</a:t>
            </a:r>
            <a:r>
              <a:rPr lang="fr-FR" sz="1000" b="1" dirty="0" smtClean="0"/>
              <a:t>-Estradiol 10</a:t>
            </a:r>
            <a:r>
              <a:rPr lang="fr-FR" sz="1000" b="1" baseline="30000" dirty="0" smtClean="0"/>
              <a:t>-6</a:t>
            </a:r>
            <a:r>
              <a:rPr lang="fr-FR" sz="1000" b="1" dirty="0" smtClean="0"/>
              <a:t>M </a:t>
            </a:r>
            <a:endParaRPr lang="fr-FR" sz="1000" b="1" dirty="0"/>
          </a:p>
        </p:txBody>
      </p:sp>
      <p:sp>
        <p:nvSpPr>
          <p:cNvPr id="10" name="ZoneTexte 9"/>
          <p:cNvSpPr txBox="1"/>
          <p:nvPr/>
        </p:nvSpPr>
        <p:spPr>
          <a:xfrm>
            <a:off x="4395454" y="3379433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17</a:t>
            </a:r>
            <a:r>
              <a:rPr lang="el-GR" sz="1000" b="1" dirty="0" smtClean="0"/>
              <a:t>β</a:t>
            </a:r>
            <a:r>
              <a:rPr lang="fr-FR" sz="1000" b="1" dirty="0" smtClean="0"/>
              <a:t>-Estradiol 10</a:t>
            </a:r>
            <a:r>
              <a:rPr lang="fr-FR" sz="1000" b="1" baseline="30000" dirty="0" smtClean="0"/>
              <a:t>-8</a:t>
            </a:r>
            <a:r>
              <a:rPr lang="fr-FR" sz="1000" b="1" dirty="0" smtClean="0"/>
              <a:t>M </a:t>
            </a:r>
            <a:endParaRPr lang="fr-FR" sz="1000" b="1" dirty="0"/>
          </a:p>
        </p:txBody>
      </p:sp>
      <p:sp>
        <p:nvSpPr>
          <p:cNvPr id="11" name="ZoneTexte 10"/>
          <p:cNvSpPr txBox="1"/>
          <p:nvPr/>
        </p:nvSpPr>
        <p:spPr>
          <a:xfrm>
            <a:off x="4395454" y="3565424"/>
            <a:ext cx="13067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17</a:t>
            </a:r>
            <a:r>
              <a:rPr lang="el-GR" sz="1000" b="1" dirty="0" smtClean="0"/>
              <a:t>β</a:t>
            </a:r>
            <a:r>
              <a:rPr lang="fr-FR" sz="1000" b="1" dirty="0" smtClean="0"/>
              <a:t>-Estradiol 10</a:t>
            </a:r>
            <a:r>
              <a:rPr lang="fr-FR" sz="1000" b="1" baseline="30000" dirty="0" smtClean="0"/>
              <a:t>-10</a:t>
            </a:r>
            <a:r>
              <a:rPr lang="fr-FR" sz="1000" b="1" dirty="0" smtClean="0"/>
              <a:t>M </a:t>
            </a:r>
            <a:endParaRPr lang="fr-FR" sz="1000" b="1" dirty="0"/>
          </a:p>
        </p:txBody>
      </p:sp>
      <p:cxnSp>
        <p:nvCxnSpPr>
          <p:cNvPr id="12" name="Connecteur droit 11"/>
          <p:cNvCxnSpPr/>
          <p:nvPr/>
        </p:nvCxnSpPr>
        <p:spPr>
          <a:xfrm>
            <a:off x="1088572" y="1250562"/>
            <a:ext cx="0" cy="312509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/>
          <p:cNvCxnSpPr/>
          <p:nvPr/>
        </p:nvCxnSpPr>
        <p:spPr>
          <a:xfrm>
            <a:off x="1083441" y="4362870"/>
            <a:ext cx="509451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996356" y="1741158"/>
            <a:ext cx="870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996356" y="4366067"/>
            <a:ext cx="870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5" name="Graphique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1334301"/>
              </p:ext>
            </p:extLst>
          </p:nvPr>
        </p:nvGraphicFramePr>
        <p:xfrm>
          <a:off x="635318" y="5336518"/>
          <a:ext cx="5750243" cy="39128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7" name="Connecteur droit 16"/>
          <p:cNvCxnSpPr/>
          <p:nvPr/>
        </p:nvCxnSpPr>
        <p:spPr>
          <a:xfrm>
            <a:off x="1021966" y="5452451"/>
            <a:ext cx="0" cy="350737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18"/>
          <p:cNvCxnSpPr/>
          <p:nvPr/>
        </p:nvCxnSpPr>
        <p:spPr>
          <a:xfrm>
            <a:off x="952297" y="8939356"/>
            <a:ext cx="526868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19"/>
          <p:cNvCxnSpPr/>
          <p:nvPr/>
        </p:nvCxnSpPr>
        <p:spPr>
          <a:xfrm>
            <a:off x="944045" y="6467585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ZoneTexte 20"/>
          <p:cNvSpPr txBox="1"/>
          <p:nvPr/>
        </p:nvSpPr>
        <p:spPr>
          <a:xfrm>
            <a:off x="765655" y="6344474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1</a:t>
            </a:r>
            <a:endParaRPr lang="fr-FR" sz="1000" b="1" dirty="0"/>
          </a:p>
        </p:txBody>
      </p:sp>
      <p:sp>
        <p:nvSpPr>
          <p:cNvPr id="22" name="Rectangle 21"/>
          <p:cNvSpPr/>
          <p:nvPr/>
        </p:nvSpPr>
        <p:spPr>
          <a:xfrm>
            <a:off x="695589" y="8786729"/>
            <a:ext cx="256708" cy="3070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ZoneTexte 22"/>
          <p:cNvSpPr txBox="1"/>
          <p:nvPr/>
        </p:nvSpPr>
        <p:spPr>
          <a:xfrm>
            <a:off x="661469" y="8836717"/>
            <a:ext cx="3481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0.2</a:t>
            </a:r>
            <a:endParaRPr lang="fr-FR" sz="1000" b="1" dirty="0"/>
          </a:p>
        </p:txBody>
      </p:sp>
      <p:sp>
        <p:nvSpPr>
          <p:cNvPr id="24" name="ZoneTexte 23"/>
          <p:cNvSpPr txBox="1"/>
          <p:nvPr/>
        </p:nvSpPr>
        <p:spPr>
          <a:xfrm rot="16200000">
            <a:off x="259732" y="7169842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OD </a:t>
            </a:r>
            <a:r>
              <a:rPr lang="fr-FR" sz="1000" b="1" baseline="-25000" dirty="0" smtClean="0"/>
              <a:t>600nm</a:t>
            </a:r>
            <a:endParaRPr lang="fr-FR" sz="1000" b="1" baseline="-25000" dirty="0"/>
          </a:p>
        </p:txBody>
      </p:sp>
      <p:sp>
        <p:nvSpPr>
          <p:cNvPr id="25" name="Ellipse 24"/>
          <p:cNvSpPr/>
          <p:nvPr/>
        </p:nvSpPr>
        <p:spPr>
          <a:xfrm>
            <a:off x="4220223" y="7326516"/>
            <a:ext cx="72427" cy="71245"/>
          </a:xfrm>
          <a:prstGeom prst="ellipse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Ellipse 25"/>
          <p:cNvSpPr/>
          <p:nvPr/>
        </p:nvSpPr>
        <p:spPr>
          <a:xfrm>
            <a:off x="4220224" y="7509288"/>
            <a:ext cx="72427" cy="71245"/>
          </a:xfrm>
          <a:prstGeom prst="ellipse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Ellipse 26"/>
          <p:cNvSpPr/>
          <p:nvPr/>
        </p:nvSpPr>
        <p:spPr>
          <a:xfrm>
            <a:off x="4220224" y="7697311"/>
            <a:ext cx="72427" cy="71245"/>
          </a:xfrm>
          <a:prstGeom prst="ellipse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" name="Ellipse 27"/>
          <p:cNvSpPr/>
          <p:nvPr/>
        </p:nvSpPr>
        <p:spPr>
          <a:xfrm>
            <a:off x="4220225" y="7885334"/>
            <a:ext cx="72427" cy="71245"/>
          </a:xfrm>
          <a:prstGeom prst="ellipse">
            <a:avLst/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ZoneTexte 28"/>
          <p:cNvSpPr txBox="1"/>
          <p:nvPr/>
        </p:nvSpPr>
        <p:spPr>
          <a:xfrm>
            <a:off x="4292650" y="7238170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Control </a:t>
            </a:r>
            <a:endParaRPr lang="fr-FR" sz="1000" b="1" dirty="0"/>
          </a:p>
        </p:txBody>
      </p:sp>
      <p:sp>
        <p:nvSpPr>
          <p:cNvPr id="30" name="ZoneTexte 29"/>
          <p:cNvSpPr txBox="1"/>
          <p:nvPr/>
        </p:nvSpPr>
        <p:spPr>
          <a:xfrm>
            <a:off x="4292650" y="7417044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17</a:t>
            </a:r>
            <a:r>
              <a:rPr lang="el-GR" sz="1000" b="1" dirty="0" smtClean="0"/>
              <a:t>β</a:t>
            </a:r>
            <a:r>
              <a:rPr lang="fr-FR" sz="1000" b="1" dirty="0" smtClean="0"/>
              <a:t>-Estradiol 10</a:t>
            </a:r>
            <a:r>
              <a:rPr lang="fr-FR" sz="1000" b="1" baseline="30000" dirty="0" smtClean="0"/>
              <a:t>-6</a:t>
            </a:r>
            <a:r>
              <a:rPr lang="fr-FR" sz="1000" b="1" dirty="0" smtClean="0"/>
              <a:t>M </a:t>
            </a:r>
            <a:endParaRPr lang="fr-FR" sz="1000" b="1" dirty="0"/>
          </a:p>
        </p:txBody>
      </p:sp>
      <p:sp>
        <p:nvSpPr>
          <p:cNvPr id="31" name="ZoneTexte 30"/>
          <p:cNvSpPr txBox="1"/>
          <p:nvPr/>
        </p:nvSpPr>
        <p:spPr>
          <a:xfrm>
            <a:off x="4292649" y="7617635"/>
            <a:ext cx="12634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17</a:t>
            </a:r>
            <a:r>
              <a:rPr lang="el-GR" sz="1000" b="1" dirty="0" smtClean="0"/>
              <a:t>β</a:t>
            </a:r>
            <a:r>
              <a:rPr lang="fr-FR" sz="1000" b="1" dirty="0" smtClean="0"/>
              <a:t>-Estradiol 10</a:t>
            </a:r>
            <a:r>
              <a:rPr lang="fr-FR" sz="1000" b="1" baseline="30000" dirty="0" smtClean="0"/>
              <a:t>-8</a:t>
            </a:r>
            <a:r>
              <a:rPr lang="fr-FR" sz="1000" b="1" dirty="0" smtClean="0"/>
              <a:t>M </a:t>
            </a:r>
            <a:endParaRPr lang="fr-FR" sz="1000" b="1" dirty="0"/>
          </a:p>
        </p:txBody>
      </p:sp>
      <p:sp>
        <p:nvSpPr>
          <p:cNvPr id="32" name="ZoneTexte 31"/>
          <p:cNvSpPr txBox="1"/>
          <p:nvPr/>
        </p:nvSpPr>
        <p:spPr>
          <a:xfrm>
            <a:off x="4292649" y="7803626"/>
            <a:ext cx="13067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smtClean="0"/>
              <a:t>17</a:t>
            </a:r>
            <a:r>
              <a:rPr lang="el-GR" sz="1000" b="1" dirty="0" smtClean="0"/>
              <a:t>β</a:t>
            </a:r>
            <a:r>
              <a:rPr lang="fr-FR" sz="1000" b="1" dirty="0" smtClean="0"/>
              <a:t>-Estradiol 10</a:t>
            </a:r>
            <a:r>
              <a:rPr lang="fr-FR" sz="1000" b="1" baseline="30000" dirty="0" smtClean="0"/>
              <a:t>-10</a:t>
            </a:r>
            <a:r>
              <a:rPr lang="fr-FR" sz="1000" b="1" dirty="0" smtClean="0"/>
              <a:t>M </a:t>
            </a:r>
            <a:endParaRPr lang="fr-FR" sz="1000" b="1" dirty="0"/>
          </a:p>
        </p:txBody>
      </p:sp>
      <p:sp>
        <p:nvSpPr>
          <p:cNvPr id="35" name="ZoneTexte 34"/>
          <p:cNvSpPr txBox="1"/>
          <p:nvPr/>
        </p:nvSpPr>
        <p:spPr>
          <a:xfrm>
            <a:off x="441527" y="115786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36" name="ZoneTexte 35"/>
          <p:cNvSpPr txBox="1"/>
          <p:nvPr/>
        </p:nvSpPr>
        <p:spPr>
          <a:xfrm>
            <a:off x="441527" y="534808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326794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37</Words>
  <Application>Microsoft Office PowerPoint</Application>
  <PresentationFormat>Format A4 (210 x 297 mm)</PresentationFormat>
  <Paragraphs>1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UT-Evreux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XIMILIEN CLABAUT (Etudiant)</dc:creator>
  <cp:lastModifiedBy>MARC FEUILLOLEY (Personnel)</cp:lastModifiedBy>
  <cp:revision>7</cp:revision>
  <dcterms:created xsi:type="dcterms:W3CDTF">2020-09-24T15:35:36Z</dcterms:created>
  <dcterms:modified xsi:type="dcterms:W3CDTF">2021-05-11T14:54:02Z</dcterms:modified>
</cp:coreProperties>
</file>